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FBCA7-130B-4E76-AB9E-00BE8F3F60BE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EBBAC-BE31-4758-B4D8-DF518CE840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FBCA7-130B-4E76-AB9E-00BE8F3F60BE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EBBAC-BE31-4758-B4D8-DF518CE840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FBCA7-130B-4E76-AB9E-00BE8F3F60BE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EBBAC-BE31-4758-B4D8-DF518CE840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FBCA7-130B-4E76-AB9E-00BE8F3F60BE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EBBAC-BE31-4758-B4D8-DF518CE840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FBCA7-130B-4E76-AB9E-00BE8F3F60BE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EBBAC-BE31-4758-B4D8-DF518CE840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FBCA7-130B-4E76-AB9E-00BE8F3F60BE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EBBAC-BE31-4758-B4D8-DF518CE840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FBCA7-130B-4E76-AB9E-00BE8F3F60BE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EBBAC-BE31-4758-B4D8-DF518CE840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FBCA7-130B-4E76-AB9E-00BE8F3F60BE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EBBAC-BE31-4758-B4D8-DF518CE840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FBCA7-130B-4E76-AB9E-00BE8F3F60BE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EBBAC-BE31-4758-B4D8-DF518CE840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FBCA7-130B-4E76-AB9E-00BE8F3F60BE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EBBAC-BE31-4758-B4D8-DF518CE840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FBCA7-130B-4E76-AB9E-00BE8F3F60BE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EBBAC-BE31-4758-B4D8-DF518CE840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7FBCA7-130B-4E76-AB9E-00BE8F3F60BE}" type="datetimeFigureOut">
              <a:rPr lang="es-ES" smtClean="0"/>
              <a:pPr/>
              <a:t>13/12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4EBBAC-BE31-4758-B4D8-DF518CE840CA}" type="slidenum">
              <a:rPr lang="es-ES" smtClean="0"/>
              <a:pPr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Frontiers\IGV screenshots\ACC-oxidaseLOC111997351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719253"/>
            <a:ext cx="9144000" cy="5419493"/>
          </a:xfrm>
          <a:prstGeom prst="rect">
            <a:avLst/>
          </a:prstGeom>
          <a:noFill/>
        </p:spPr>
      </p:pic>
      <p:sp>
        <p:nvSpPr>
          <p:cNvPr id="5" name="4 CuadroTexto"/>
          <p:cNvSpPr txBox="1"/>
          <p:nvPr/>
        </p:nvSpPr>
        <p:spPr>
          <a:xfrm>
            <a:off x="179512" y="6309320"/>
            <a:ext cx="84969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Figure S1A.- Integrative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Genomic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Viewer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creenshot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mapping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read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ix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librarie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o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i="1" dirty="0">
                <a:latin typeface="Times New Roman" pitchFamily="18" charset="0"/>
                <a:cs typeface="Times New Roman" pitchFamily="18" charset="0"/>
              </a:rPr>
              <a:t>ACC oxidase 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(LOC111997351) gene locus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D:\Frontiers\IGV screenshots\NRT1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719253"/>
            <a:ext cx="9144000" cy="5419493"/>
          </a:xfrm>
          <a:prstGeom prst="rect">
            <a:avLst/>
          </a:prstGeom>
          <a:noFill/>
        </p:spPr>
      </p:pic>
      <p:sp>
        <p:nvSpPr>
          <p:cNvPr id="5" name="4 CuadroTexto"/>
          <p:cNvSpPr txBox="1"/>
          <p:nvPr/>
        </p:nvSpPr>
        <p:spPr>
          <a:xfrm>
            <a:off x="179512" y="6309320"/>
            <a:ext cx="84969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Figure S1B.- .- Integrative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Genomic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Viewer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creenshot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mapping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read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ix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librarie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o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i="1" dirty="0">
                <a:latin typeface="Times New Roman" pitchFamily="18" charset="0"/>
                <a:cs typeface="Times New Roman" pitchFamily="18" charset="0"/>
              </a:rPr>
              <a:t>NRT1 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(LOC111983151) gene locus.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D:\Frontiers\IGV screenshots\RAP2.3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719253"/>
            <a:ext cx="9144000" cy="5419493"/>
          </a:xfrm>
          <a:prstGeom prst="rect">
            <a:avLst/>
          </a:prstGeom>
          <a:noFill/>
        </p:spPr>
      </p:pic>
      <p:sp>
        <p:nvSpPr>
          <p:cNvPr id="5" name="4 CuadroTexto"/>
          <p:cNvSpPr txBox="1"/>
          <p:nvPr/>
        </p:nvSpPr>
        <p:spPr>
          <a:xfrm>
            <a:off x="179512" y="6309320"/>
            <a:ext cx="85689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Figure S1C.- Integrative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Genomic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Viewer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creenshot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mapping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read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ix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librarie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o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thylen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-responsive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ranscript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factor </a:t>
            </a:r>
            <a:r>
              <a:rPr lang="es-ES" sz="1200" i="1" dirty="0">
                <a:latin typeface="Times New Roman" pitchFamily="18" charset="0"/>
                <a:cs typeface="Times New Roman" pitchFamily="18" charset="0"/>
              </a:rPr>
              <a:t>RAP2.3 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(LOC111984856) gene locus.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D:\Frontiers\IGV screenshots\RAP2.7_BS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719253"/>
            <a:ext cx="9144000" cy="5419493"/>
          </a:xfrm>
          <a:prstGeom prst="rect">
            <a:avLst/>
          </a:prstGeom>
          <a:noFill/>
        </p:spPr>
      </p:pic>
      <p:sp>
        <p:nvSpPr>
          <p:cNvPr id="5" name="4 CuadroTexto"/>
          <p:cNvSpPr txBox="1"/>
          <p:nvPr/>
        </p:nvSpPr>
        <p:spPr>
          <a:xfrm>
            <a:off x="179512" y="6309320"/>
            <a:ext cx="84969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s-ES" sz="1200">
                <a:latin typeface="Times New Roman" pitchFamily="18" charset="0"/>
                <a:cs typeface="Times New Roman" pitchFamily="18" charset="0"/>
              </a:rPr>
              <a:t> Figure S1D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-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Integrativ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Genomic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Viewer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creenshot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mapping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read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ix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librarie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o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thylen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-responsive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ranscript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factor </a:t>
            </a:r>
            <a:r>
              <a:rPr lang="es-ES" sz="1200" i="1" dirty="0">
                <a:latin typeface="Times New Roman" pitchFamily="18" charset="0"/>
                <a:cs typeface="Times New Roman" pitchFamily="18" charset="0"/>
              </a:rPr>
              <a:t>RAP2.7 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(LOC111017577) gene locus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16</Words>
  <Application>Microsoft Office PowerPoint</Application>
  <PresentationFormat>On-screen Show (4:3)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Tema de Offic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44428400J</dc:creator>
  <cp:lastModifiedBy>MDPI</cp:lastModifiedBy>
  <cp:revision>5</cp:revision>
  <dcterms:created xsi:type="dcterms:W3CDTF">2022-04-04T13:15:37Z</dcterms:created>
  <dcterms:modified xsi:type="dcterms:W3CDTF">2022-12-13T07:21:02Z</dcterms:modified>
</cp:coreProperties>
</file>